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4" r:id="rId4"/>
    <p:sldId id="266" r:id="rId5"/>
    <p:sldId id="26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0" d="100"/>
          <a:sy n="70" d="100"/>
        </p:scale>
        <p:origin x="6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0552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975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0411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58864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4096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3980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310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094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8151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2293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722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F0276-1061-4634-9EE3-25D5ACC2A482}" type="datetimeFigureOut">
              <a:rPr lang="en-IN" smtClean="0"/>
              <a:t>03-06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1318F-4A8D-48F7-8EB8-A88D9A2FC69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645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www.pseudomonas.com/" TargetMode="Externa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393451" y="1026589"/>
            <a:ext cx="9708776" cy="4328296"/>
            <a:chOff x="1250576" y="569389"/>
            <a:chExt cx="9708776" cy="4328296"/>
          </a:xfrm>
        </p:grpSpPr>
        <p:pic>
          <p:nvPicPr>
            <p:cNvPr id="3" name="Picture 2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73822" y="569389"/>
              <a:ext cx="3528000" cy="3636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" name="Rectangle 3"/>
            <p:cNvSpPr/>
            <p:nvPr/>
          </p:nvSpPr>
          <p:spPr>
            <a:xfrm>
              <a:off x="1250576" y="4374465"/>
              <a:ext cx="9708776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800"/>
                </a:spcAft>
              </a:pPr>
              <a:r>
                <a:rPr lang="en-IN" sz="14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N" sz="14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S1.</a:t>
              </a:r>
              <a:r>
                <a:rPr lang="en-IN" sz="14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Screening of carvacrol resistant isolates on HE agar </a:t>
              </a:r>
              <a:r>
                <a:rPr lang="en-IN" sz="14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dia (HiMedia, India). </a:t>
              </a:r>
              <a:r>
                <a:rPr lang="en-IN" sz="14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he suspected isolates were</a:t>
              </a:r>
              <a:r>
                <a:rPr lang="en-IN" sz="1400" i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N" sz="14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reaked perpendicular to</a:t>
              </a:r>
              <a:r>
                <a:rPr lang="en-IN" sz="1400" i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N" sz="14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4 % 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vacrol strips. The growth was observed near the carvacrol strip in resistant isolates. </a:t>
              </a:r>
              <a:endParaRPr lang="en-IN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2" descr="E:\PhD\prasanna study pics\screening carvacrol resistance strip method\IMG_20150128_141520448.jpg"/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l="11942" t="3395" r="16726"/>
            <a:stretch/>
          </p:blipFill>
          <p:spPr bwMode="auto">
            <a:xfrm rot="5400000">
              <a:off x="2527497" y="559064"/>
              <a:ext cx="3636000" cy="3656650"/>
            </a:xfrm>
            <a:prstGeom prst="rect">
              <a:avLst/>
            </a:prstGeom>
            <a:noFill/>
          </p:spPr>
        </p:pic>
        <p:cxnSp>
          <p:nvCxnSpPr>
            <p:cNvPr id="6" name="Straight Arrow Connector 5"/>
            <p:cNvCxnSpPr/>
            <p:nvPr/>
          </p:nvCxnSpPr>
          <p:spPr>
            <a:xfrm flipH="1" flipV="1">
              <a:off x="4626260" y="2501152"/>
              <a:ext cx="268466" cy="32272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405333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01532" y="4722398"/>
            <a:ext cx="8112777" cy="95410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CR confirmation of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eruginosa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us specific PCR for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,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duced amplicon size of 618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specific PCR for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 aeruginos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amplicon size of 956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ne M: Molecular weight marker; Lane 1 to 10: Isolates positive f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eruginos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genus and species specific PCR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11: Negative control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9030" t="16208" r="29967" b="37377"/>
          <a:stretch/>
        </p:blipFill>
        <p:spPr>
          <a:xfrm>
            <a:off x="1464888" y="1610285"/>
            <a:ext cx="3294531" cy="2796989"/>
          </a:xfrm>
          <a:prstGeom prst="rect">
            <a:avLst/>
          </a:prstGeom>
          <a:ln>
            <a:noFill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1498937" y="1363663"/>
            <a:ext cx="3363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 1  2   3   4   5   6   7   8  9  10 11 M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107053" y="3316680"/>
            <a:ext cx="8791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  <a:latin typeface="Arial Narrow" panose="020B0606020202030204" pitchFamily="34" charset="0"/>
              </a:rPr>
              <a:t>500 </a:t>
            </a:r>
            <a:r>
              <a:rPr lang="en-US" dirty="0" err="1" smtClean="0">
                <a:solidFill>
                  <a:schemeClr val="bg1"/>
                </a:solidFill>
                <a:latin typeface="Arial Narrow" panose="020B0606020202030204" pitchFamily="34" charset="0"/>
              </a:rPr>
              <a:t>bp</a:t>
            </a:r>
            <a:endParaRPr lang="en-US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941122" y="3395652"/>
            <a:ext cx="5725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4707165" y="3523414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941122" y="3268694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18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4232550" y="3413070"/>
            <a:ext cx="792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1342" t="15040" r="24078" b="28697"/>
          <a:stretch/>
        </p:blipFill>
        <p:spPr>
          <a:xfrm>
            <a:off x="5988931" y="1633977"/>
            <a:ext cx="3525379" cy="2773297"/>
          </a:xfrm>
          <a:prstGeom prst="rect">
            <a:avLst/>
          </a:prstGeom>
          <a:ln>
            <a:noFill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820265" y="1532940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388506" y="1592030"/>
            <a:ext cx="66396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8956950" y="2896730"/>
            <a:ext cx="792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9514310" y="3196447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9768394" y="3071053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933564" y="1373016"/>
            <a:ext cx="38153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  1   2    3   4    5   6   7   8   9   10 11 M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748950" y="2772035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6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9534013" y="3592625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9788097" y="3479786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9514310" y="3441801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9768394" y="3328962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9777210" y="3186061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9534013" y="3323052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9518718" y="3108262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9772802" y="2982868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204597" y="2728952"/>
            <a:ext cx="6222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Arrow Connector 27"/>
          <p:cNvCxnSpPr/>
          <p:nvPr/>
        </p:nvCxnSpPr>
        <p:spPr>
          <a:xfrm flipH="1" flipV="1">
            <a:off x="5759557" y="2862903"/>
            <a:ext cx="292913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4747598" y="3981066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974788" y="3868227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4748991" y="3846414"/>
            <a:ext cx="32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5003075" y="3733575"/>
            <a:ext cx="5549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67385" y="3614311"/>
            <a:ext cx="622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1082493" y="3748029"/>
            <a:ext cx="382395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573715" y="3496220"/>
            <a:ext cx="622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1088823" y="3629938"/>
            <a:ext cx="382395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576807" y="3404759"/>
            <a:ext cx="622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1091915" y="3538477"/>
            <a:ext cx="382395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82532" y="3301350"/>
            <a:ext cx="622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Straight Arrow Connector 42"/>
          <p:cNvCxnSpPr/>
          <p:nvPr/>
        </p:nvCxnSpPr>
        <p:spPr>
          <a:xfrm>
            <a:off x="1084193" y="3435068"/>
            <a:ext cx="382395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450435" y="3104067"/>
            <a:ext cx="622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00 bp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Straight Arrow Connector 44"/>
          <p:cNvCxnSpPr/>
          <p:nvPr/>
        </p:nvCxnSpPr>
        <p:spPr>
          <a:xfrm>
            <a:off x="952096" y="3237785"/>
            <a:ext cx="512792" cy="12019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8063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24586" y="582681"/>
            <a:ext cx="6741661" cy="4098501"/>
            <a:chOff x="620936" y="138910"/>
            <a:chExt cx="10161675" cy="5102923"/>
          </a:xfrm>
        </p:grpSpPr>
        <p:pic>
          <p:nvPicPr>
            <p:cNvPr id="3" name="Picture 2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4927" y="153259"/>
              <a:ext cx="6400800" cy="508857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9522608" y="2851716"/>
              <a:ext cx="1182076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 bp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20936" y="2884396"/>
              <a:ext cx="1182076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94 bp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H="1">
              <a:off x="1864805" y="3115228"/>
              <a:ext cx="1290722" cy="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>
              <a:off x="8854946" y="3064132"/>
              <a:ext cx="633131" cy="112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9630906" y="4157230"/>
              <a:ext cx="1151705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 bp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>
              <a:off x="8854945" y="4299860"/>
              <a:ext cx="633131" cy="112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9605967" y="3754493"/>
              <a:ext cx="1151705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 bp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>
              <a:off x="8854945" y="3865932"/>
              <a:ext cx="633131" cy="112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9578787" y="3399237"/>
              <a:ext cx="1151705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 bp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8854946" y="3503754"/>
              <a:ext cx="633131" cy="112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9578787" y="3150389"/>
              <a:ext cx="1151705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 bp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>
              <a:off x="8854946" y="3260058"/>
              <a:ext cx="633131" cy="11260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2573558" y="138910"/>
              <a:ext cx="7301172" cy="499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M    1      2     3    4       5     6     7      8     9    10   11    M</a:t>
              </a:r>
              <a:endParaRPr lang="en-IN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Rectangle 16"/>
          <p:cNvSpPr/>
          <p:nvPr/>
        </p:nvSpPr>
        <p:spPr>
          <a:xfrm>
            <a:off x="1678121" y="4930385"/>
            <a:ext cx="948574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R confirmation for transposon insertion in mutants. Lane 1 to 7: Confirmed mutants positive for transposon insertion; Lane 8: Wild type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PA-Y7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Lane 9-10: Negative controls; Lane 11: Blank (without Template); Lane M: 100 bp molecular weight marker.</a:t>
            </a:r>
            <a:endParaRPr lang="en-IN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545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737935" y="222195"/>
            <a:ext cx="10892590" cy="4856933"/>
            <a:chOff x="737935" y="222195"/>
            <a:chExt cx="10892590" cy="485693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7936" y="222195"/>
              <a:ext cx="10892589" cy="2055784"/>
            </a:xfrm>
            <a:prstGeom prst="rect">
              <a:avLst/>
            </a:prstGeom>
            <a:ln w="12700">
              <a:solidFill>
                <a:srgbClr val="00B050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7935" y="2445246"/>
              <a:ext cx="10892589" cy="2158838"/>
            </a:xfrm>
            <a:prstGeom prst="rect">
              <a:avLst/>
            </a:prstGeom>
            <a:ln w="12700">
              <a:solidFill>
                <a:srgbClr val="0070C0"/>
              </a:solidFill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8835258" y="401190"/>
              <a:ext cx="221055" cy="272046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9056313" y="401190"/>
              <a:ext cx="20929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ytoplasmic Protein</a:t>
              </a:r>
              <a:endParaRPr lang="en-IN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37935" y="4771351"/>
              <a:ext cx="1089258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just"/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50231" y="295428"/>
              <a:ext cx="434144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 stream to transposon insertion site</a:t>
              </a:r>
              <a:endParaRPr lang="en-IN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50231" y="2351212"/>
              <a:ext cx="465563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wn stream to transposon insertion site</a:t>
              </a:r>
              <a:endParaRPr lang="en-IN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737936" y="5079128"/>
            <a:ext cx="1089258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dentification of transposon inactivated gene using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eruginosa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O1 as reference strain.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ter identification of transposon insertion in the genome by local BLAST, about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 bases upstream and downstream to the transposon inserted site was searched by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BLAST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ome database (</a:t>
            </a:r>
            <a:r>
              <a:rPr lang="en-US" u="sng" dirty="0">
                <a:solidFill>
                  <a:srgbClr val="0000FF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www.pseudomonas.com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The upstream sequence and downstream sequence matched with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xA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of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eudomonas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eruginosa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 PAO1 (indicated by black box). The genomic context is shown here.</a:t>
            </a:r>
            <a:endParaRPr lang="en-IN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1672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771525" y="854267"/>
            <a:ext cx="10758487" cy="5250655"/>
            <a:chOff x="771525" y="854267"/>
            <a:chExt cx="10758487" cy="5250655"/>
          </a:xfrm>
        </p:grpSpPr>
        <p:grpSp>
          <p:nvGrpSpPr>
            <p:cNvPr id="11" name="Group 10"/>
            <p:cNvGrpSpPr/>
            <p:nvPr/>
          </p:nvGrpSpPr>
          <p:grpSpPr>
            <a:xfrm>
              <a:off x="1992685" y="854267"/>
              <a:ext cx="7530353" cy="3132921"/>
              <a:chOff x="1992685" y="854267"/>
              <a:chExt cx="7530353" cy="3132921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1992685" y="854267"/>
                <a:ext cx="7530353" cy="3132921"/>
                <a:chOff x="1949823" y="582804"/>
                <a:chExt cx="7530353" cy="3132921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>
                  <a:off x="1949823" y="3407948"/>
                  <a:ext cx="7530353" cy="30777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just"/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6" name="Picture 15"/>
                <p:cNvPicPr/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23883" y="582804"/>
                  <a:ext cx="5397913" cy="2671384"/>
                </a:xfrm>
                <a:prstGeom prst="rect">
                  <a:avLst/>
                </a:prstGeom>
                <a:ln w="19050">
                  <a:noFill/>
                </a:ln>
                <a:effectLst/>
              </p:spPr>
            </p:pic>
          </p:grpSp>
          <p:sp>
            <p:nvSpPr>
              <p:cNvPr id="14" name="TextBox 13"/>
              <p:cNvSpPr txBox="1"/>
              <p:nvPr/>
            </p:nvSpPr>
            <p:spPr>
              <a:xfrm>
                <a:off x="2866745" y="854267"/>
                <a:ext cx="6890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-Y7</a:t>
                </a:r>
                <a:endParaRPr lang="en-I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181837" y="854267"/>
                <a:ext cx="10113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-</a:t>
                </a:r>
                <a:r>
                  <a:rPr lang="el-G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n-US" sz="14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xA</a:t>
                </a:r>
                <a:endParaRPr lang="en-IN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2416249" y="1974515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P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" name="Straight Arrow Connector 2"/>
            <p:cNvCxnSpPr/>
            <p:nvPr/>
          </p:nvCxnSpPr>
          <p:spPr>
            <a:xfrm flipH="1" flipV="1">
              <a:off x="2773744" y="2079891"/>
              <a:ext cx="536002" cy="192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/>
            <p:cNvSpPr txBox="1"/>
            <p:nvPr/>
          </p:nvSpPr>
          <p:spPr>
            <a:xfrm>
              <a:off x="2356129" y="2580517"/>
              <a:ext cx="2680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" name="Straight Arrow Connector 4"/>
            <p:cNvCxnSpPr>
              <a:endCxn id="4" idx="3"/>
            </p:cNvCxnSpPr>
            <p:nvPr/>
          </p:nvCxnSpPr>
          <p:spPr>
            <a:xfrm flipH="1" flipV="1">
              <a:off x="2624151" y="2695933"/>
              <a:ext cx="764322" cy="1990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5296280" y="1238758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Straight Arrow Connector 6"/>
            <p:cNvCxnSpPr/>
            <p:nvPr/>
          </p:nvCxnSpPr>
          <p:spPr>
            <a:xfrm flipV="1">
              <a:off x="4676976" y="1392518"/>
              <a:ext cx="737706" cy="35704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>
              <a:off x="4676976" y="2520768"/>
              <a:ext cx="619304" cy="4983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5227724" y="2988262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771525" y="4073597"/>
              <a:ext cx="10758487" cy="203132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Bef>
                  <a:spcPts val="600"/>
                </a:spcBef>
                <a:spcAft>
                  <a:spcPts val="1200"/>
                </a:spcAft>
              </a:pPr>
              <a:r>
                <a:rPr lang="en-US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S5</a:t>
              </a:r>
              <a:r>
                <a:rPr lang="en-US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Herbal </a:t>
              </a:r>
              <a:r>
                <a:rPr lang="en-US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timicrobial susceptibility testing of PA-Y7 and PA-</a:t>
              </a:r>
              <a:r>
                <a:rPr lang="el-GR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Δ</a:t>
              </a:r>
              <a:r>
                <a:rPr lang="en-US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xA on MHA plates. </a:t>
              </a:r>
              <a:r>
                <a:rPr lang="en-US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ch herbal disc contain 1 mg of pure compound while antibiotic discs contains The </a:t>
              </a:r>
              <a:r>
                <a:rPr lang="en-US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A-Y7 strain was resistant to all the herbal compounds (disc number 0 to 14) while PA-</a:t>
              </a:r>
              <a:r>
                <a:rPr lang="el-GR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Δ</a:t>
              </a:r>
              <a:r>
                <a:rPr lang="en-US" i="1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xA</a:t>
              </a:r>
              <a:r>
                <a:rPr lang="en-US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was susceptible to carvacrol (disc number 4), cinnamon oil (disc number 8), cinnamaldehyde (disc number 10) and thyme oil (disc number 13). The herbal discs are numbered (0 to 13</a:t>
              </a:r>
              <a:r>
                <a:rPr lang="en-US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. The control disc ciprofloxacin-5µg (CIP), chloramphenicol-30µg (C) has shown greater zone of inhibition (32 and 22 respectively) in PA-</a:t>
              </a:r>
              <a:r>
                <a:rPr lang="el-GR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Δ</a:t>
              </a:r>
              <a:r>
                <a:rPr lang="en-US" i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xA</a:t>
              </a:r>
              <a:r>
                <a:rPr lang="en-US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strain as compared to PA-Y7. Whereas colistin-10µg (CL), and polymyxin-B-300 units (PB) did not show difference in the zone of inhibition between the strains.</a:t>
              </a:r>
              <a:endParaRPr lang="en-IN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54790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74</TotalTime>
  <Words>506</Words>
  <Application>Microsoft Office PowerPoint</Application>
  <PresentationFormat>Widescreen</PresentationFormat>
  <Paragraphs>4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wan Kumar</dc:creator>
  <cp:lastModifiedBy>Pawan Kumar</cp:lastModifiedBy>
  <cp:revision>28</cp:revision>
  <dcterms:created xsi:type="dcterms:W3CDTF">2019-01-04T10:47:00Z</dcterms:created>
  <dcterms:modified xsi:type="dcterms:W3CDTF">2019-06-05T05:47:31Z</dcterms:modified>
</cp:coreProperties>
</file>